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3.xml" ContentType="application/vnd.openxmlformats-officedocument.presentationml.notesSlide+xml"/>
  <Override PartName="/ppt/comments/comment1.xml" ContentType="application/vnd.openxmlformats-officedocument.presentationml.comments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60" r:id="rId4"/>
    <p:sldId id="258" r:id="rId5"/>
    <p:sldId id="259" r:id="rId6"/>
  </p:sldIdLst>
  <p:sldSz cx="5184775" cy="80645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0" roundtripDataSignature="AMtx7mjzkc30/oGX/JBtBmCTVaHUO000rw==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all, Wendy" initials="" lastIdx="1" clrIdx="0"/>
  <p:cmAuthor id="1" name="Wendy Hall" initials="" lastIdx="1" clrIdx="1"/>
  <p:cmAuthor id="2" name="Hall, Wendy" initials="HW" lastIdx="2" clrIdx="2">
    <p:extLst>
      <p:ext uri="{19B8F6BF-5375-455C-9EA6-DF929625EA0E}">
        <p15:presenceInfo xmlns:p15="http://schemas.microsoft.com/office/powerpoint/2012/main" userId="S::sttb1953@kcl.ac.uk::03666eff-ddf3-42c7-b19e-f0e4c27e93c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595"/>
  </p:normalViewPr>
  <p:slideViewPr>
    <p:cSldViewPr snapToGrid="0" snapToObjects="1">
      <p:cViewPr varScale="1">
        <p:scale>
          <a:sx n="92" d="100"/>
          <a:sy n="92" d="100"/>
        </p:scale>
        <p:origin x="334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customschemas.google.com/relationships/presentationmetadata" Target="metadata"/><Relationship Id="rId4" Type="http://schemas.openxmlformats.org/officeDocument/2006/relationships/slide" Target="slides/slide3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charlottemills\OneDrive%20-%20University%20of%20Reading\Publications\Intermet\Rebuttal%20\Rebuttal%20final\Data_NEF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924345964970301"/>
          <c:y val="2.7561618232287005E-2"/>
          <c:w val="0.65081787791573442"/>
          <c:h val="0.69197116584144813"/>
        </c:manualLayout>
      </c:layout>
      <c:lineChart>
        <c:grouping val="standard"/>
        <c:varyColors val="0"/>
        <c:ser>
          <c:idx val="0"/>
          <c:order val="0"/>
          <c:tx>
            <c:strRef>
              <c:f>'NEFA data'!$B$32</c:f>
              <c:strCache>
                <c:ptCount val="1"/>
                <c:pt idx="0">
                  <c:v>Non-IE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NEFA data'!$C$26:$K$26</c:f>
                <c:numCache>
                  <c:formatCode>General</c:formatCode>
                  <c:ptCount val="9"/>
                  <c:pt idx="0">
                    <c:v>4.1459396750885925E-2</c:v>
                  </c:pt>
                  <c:pt idx="1">
                    <c:v>1.9280137038167715E-2</c:v>
                  </c:pt>
                  <c:pt idx="2">
                    <c:v>1.0179959673170032E-2</c:v>
                  </c:pt>
                  <c:pt idx="3">
                    <c:v>2.2553736999255326E-2</c:v>
                  </c:pt>
                  <c:pt idx="4">
                    <c:v>3.7607914900428772E-2</c:v>
                  </c:pt>
                  <c:pt idx="5">
                    <c:v>3.3422927837985089E-2</c:v>
                  </c:pt>
                  <c:pt idx="6">
                    <c:v>3.5547595965794446E-2</c:v>
                  </c:pt>
                  <c:pt idx="7">
                    <c:v>4.0561032635043237E-2</c:v>
                  </c:pt>
                  <c:pt idx="8">
                    <c:v>3.960728269024847E-2</c:v>
                  </c:pt>
                </c:numCache>
              </c:numRef>
            </c:plus>
            <c:minus>
              <c:numRef>
                <c:f>'NEFA data'!$C$26:$K$26</c:f>
                <c:numCache>
                  <c:formatCode>General</c:formatCode>
                  <c:ptCount val="9"/>
                  <c:pt idx="0">
                    <c:v>4.1459396750885925E-2</c:v>
                  </c:pt>
                  <c:pt idx="1">
                    <c:v>1.9280137038167715E-2</c:v>
                  </c:pt>
                  <c:pt idx="2">
                    <c:v>1.0179959673170032E-2</c:v>
                  </c:pt>
                  <c:pt idx="3">
                    <c:v>2.2553736999255326E-2</c:v>
                  </c:pt>
                  <c:pt idx="4">
                    <c:v>3.7607914900428772E-2</c:v>
                  </c:pt>
                  <c:pt idx="5">
                    <c:v>3.3422927837985089E-2</c:v>
                  </c:pt>
                  <c:pt idx="6">
                    <c:v>3.5547595965794446E-2</c:v>
                  </c:pt>
                  <c:pt idx="7">
                    <c:v>4.0561032635043237E-2</c:v>
                  </c:pt>
                  <c:pt idx="8">
                    <c:v>3.96072826902484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NEFA data'!$C$31:$K$31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</c:numCache>
            </c:numRef>
          </c:cat>
          <c:val>
            <c:numRef>
              <c:f>'NEFA data'!$C$32:$K$32</c:f>
              <c:numCache>
                <c:formatCode>0.00</c:formatCode>
                <c:ptCount val="9"/>
                <c:pt idx="0">
                  <c:v>0.55249999999999999</c:v>
                </c:pt>
                <c:pt idx="1">
                  <c:v>0.14349999999999999</c:v>
                </c:pt>
                <c:pt idx="2">
                  <c:v>8.9000000000000024E-2</c:v>
                </c:pt>
                <c:pt idx="3">
                  <c:v>0.14450000000000002</c:v>
                </c:pt>
                <c:pt idx="4">
                  <c:v>0.27350000000000008</c:v>
                </c:pt>
                <c:pt idx="5">
                  <c:v>0.26450000000000001</c:v>
                </c:pt>
                <c:pt idx="6">
                  <c:v>0.41100000000000003</c:v>
                </c:pt>
                <c:pt idx="7">
                  <c:v>0.47750000000000015</c:v>
                </c:pt>
                <c:pt idx="8">
                  <c:v>0.578000000000000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CC4-0C44-8E84-EE002299F6D9}"/>
            </c:ext>
          </c:extLst>
        </c:ser>
        <c:ser>
          <c:idx val="1"/>
          <c:order val="1"/>
          <c:tx>
            <c:strRef>
              <c:f>'NEFA data'!$B$33</c:f>
              <c:strCache>
                <c:ptCount val="1"/>
                <c:pt idx="0">
                  <c:v>IE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NEFA data'!$L$26:$T$26</c:f>
                <c:numCache>
                  <c:formatCode>General</c:formatCode>
                  <c:ptCount val="9"/>
                  <c:pt idx="0">
                    <c:v>5.5329039676999134E-2</c:v>
                  </c:pt>
                  <c:pt idx="1">
                    <c:v>1.6865957616328513E-2</c:v>
                  </c:pt>
                  <c:pt idx="2">
                    <c:v>1.1605352667037556E-2</c:v>
                  </c:pt>
                  <c:pt idx="3">
                    <c:v>1.9965760164525868E-2</c:v>
                  </c:pt>
                  <c:pt idx="4">
                    <c:v>3.1508353111349259E-2</c:v>
                  </c:pt>
                  <c:pt idx="5">
                    <c:v>3.473414064455585E-2</c:v>
                  </c:pt>
                  <c:pt idx="6">
                    <c:v>3.4892881192225118E-2</c:v>
                  </c:pt>
                  <c:pt idx="7">
                    <c:v>3.694305717836853E-2</c:v>
                  </c:pt>
                  <c:pt idx="8">
                    <c:v>3.8521354296573093E-2</c:v>
                  </c:pt>
                </c:numCache>
              </c:numRef>
            </c:plus>
            <c:minus>
              <c:numRef>
                <c:f>'NEFA data'!$L$26:$T$26</c:f>
                <c:numCache>
                  <c:formatCode>General</c:formatCode>
                  <c:ptCount val="9"/>
                  <c:pt idx="0">
                    <c:v>5.5329039676999134E-2</c:v>
                  </c:pt>
                  <c:pt idx="1">
                    <c:v>1.6865957616328513E-2</c:v>
                  </c:pt>
                  <c:pt idx="2">
                    <c:v>1.1605352667037556E-2</c:v>
                  </c:pt>
                  <c:pt idx="3">
                    <c:v>1.9965760164525868E-2</c:v>
                  </c:pt>
                  <c:pt idx="4">
                    <c:v>3.1508353111349259E-2</c:v>
                  </c:pt>
                  <c:pt idx="5">
                    <c:v>3.473414064455585E-2</c:v>
                  </c:pt>
                  <c:pt idx="6">
                    <c:v>3.4892881192225118E-2</c:v>
                  </c:pt>
                  <c:pt idx="7">
                    <c:v>3.694305717836853E-2</c:v>
                  </c:pt>
                  <c:pt idx="8">
                    <c:v>3.852135429657309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NEFA data'!$C$31:$K$31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</c:numCache>
            </c:numRef>
          </c:cat>
          <c:val>
            <c:numRef>
              <c:f>'NEFA data'!$C$33:$K$33</c:f>
              <c:numCache>
                <c:formatCode>0.00</c:formatCode>
                <c:ptCount val="9"/>
                <c:pt idx="0">
                  <c:v>0.53950000000000009</c:v>
                </c:pt>
                <c:pt idx="1">
                  <c:v>0.11949999999999998</c:v>
                </c:pt>
                <c:pt idx="2">
                  <c:v>7.9000000000000015E-2</c:v>
                </c:pt>
                <c:pt idx="3">
                  <c:v>0.12400000000000003</c:v>
                </c:pt>
                <c:pt idx="4">
                  <c:v>0.21350000000000002</c:v>
                </c:pt>
                <c:pt idx="5">
                  <c:v>0.28350000000000003</c:v>
                </c:pt>
                <c:pt idx="6">
                  <c:v>0.42649999999999999</c:v>
                </c:pt>
                <c:pt idx="7">
                  <c:v>0.51300000000000012</c:v>
                </c:pt>
                <c:pt idx="8">
                  <c:v>0.6039999999999998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CC4-0C44-8E84-EE002299F6D9}"/>
            </c:ext>
          </c:extLst>
        </c:ser>
        <c:ser>
          <c:idx val="2"/>
          <c:order val="2"/>
          <c:tx>
            <c:strRef>
              <c:f>'NEFA data'!$B$34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1">
                  <a:lumMod val="50000"/>
                  <a:lumOff val="50000"/>
                </a:schemeClr>
              </a:solidFill>
              <a:prstDash val="solid"/>
              <a:round/>
            </a:ln>
            <a:effectLst/>
          </c:spPr>
          <c:marker>
            <c:symbol val="square"/>
            <c:size val="5"/>
            <c:spPr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NEFA data'!$U$26:$AC$26</c:f>
                <c:numCache>
                  <c:formatCode>General</c:formatCode>
                  <c:ptCount val="9"/>
                  <c:pt idx="0">
                    <c:v>5.1388484272154533E-2</c:v>
                  </c:pt>
                  <c:pt idx="1">
                    <c:v>1.5617129596763472E-2</c:v>
                  </c:pt>
                  <c:pt idx="2">
                    <c:v>1.5642385065146428E-2</c:v>
                  </c:pt>
                  <c:pt idx="3">
                    <c:v>2.24487720916101E-2</c:v>
                  </c:pt>
                  <c:pt idx="4">
                    <c:v>2.0239032117486018E-2</c:v>
                  </c:pt>
                  <c:pt idx="5">
                    <c:v>2.0564404607041353E-2</c:v>
                  </c:pt>
                  <c:pt idx="6">
                    <c:v>2.5314859376721007E-2</c:v>
                  </c:pt>
                  <c:pt idx="7">
                    <c:v>3.5542968806487461E-2</c:v>
                  </c:pt>
                  <c:pt idx="8">
                    <c:v>5.2324393023361095E-2</c:v>
                  </c:pt>
                </c:numCache>
              </c:numRef>
            </c:plus>
            <c:minus>
              <c:numRef>
                <c:f>'NEFA data'!$U$26:$AC$26</c:f>
                <c:numCache>
                  <c:formatCode>General</c:formatCode>
                  <c:ptCount val="9"/>
                  <c:pt idx="0">
                    <c:v>5.1388484272154533E-2</c:v>
                  </c:pt>
                  <c:pt idx="1">
                    <c:v>1.5617129596763472E-2</c:v>
                  </c:pt>
                  <c:pt idx="2">
                    <c:v>1.5642385065146428E-2</c:v>
                  </c:pt>
                  <c:pt idx="3">
                    <c:v>2.24487720916101E-2</c:v>
                  </c:pt>
                  <c:pt idx="4">
                    <c:v>2.0239032117486018E-2</c:v>
                  </c:pt>
                  <c:pt idx="5">
                    <c:v>2.0564404607041353E-2</c:v>
                  </c:pt>
                  <c:pt idx="6">
                    <c:v>2.5314859376721007E-2</c:v>
                  </c:pt>
                  <c:pt idx="7">
                    <c:v>3.5542968806487461E-2</c:v>
                  </c:pt>
                  <c:pt idx="8">
                    <c:v>5.232439302336109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NEFA data'!$C$31:$K$31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</c:numCache>
            </c:numRef>
          </c:cat>
          <c:val>
            <c:numRef>
              <c:f>'NEFA data'!$C$34:$K$34</c:f>
              <c:numCache>
                <c:formatCode>0.00</c:formatCode>
                <c:ptCount val="9"/>
                <c:pt idx="0">
                  <c:v>0.5645</c:v>
                </c:pt>
                <c:pt idx="1">
                  <c:v>0.12599999999999997</c:v>
                </c:pt>
                <c:pt idx="2">
                  <c:v>0.11099999999999999</c:v>
                </c:pt>
                <c:pt idx="3">
                  <c:v>0.185</c:v>
                </c:pt>
                <c:pt idx="4">
                  <c:v>0.25650000000000006</c:v>
                </c:pt>
                <c:pt idx="5">
                  <c:v>0.30500000000000005</c:v>
                </c:pt>
                <c:pt idx="6">
                  <c:v>0.35199999999999998</c:v>
                </c:pt>
                <c:pt idx="7">
                  <c:v>0.48150000000000015</c:v>
                </c:pt>
                <c:pt idx="8">
                  <c:v>0.541000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CC4-0C44-8E84-EE002299F6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4851136"/>
        <c:axId val="1734851520"/>
      </c:lineChart>
      <c:catAx>
        <c:axId val="17348511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(hour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34851520"/>
        <c:crosses val="autoZero"/>
        <c:auto val="1"/>
        <c:lblAlgn val="ctr"/>
        <c:lblOffset val="100"/>
        <c:noMultiLvlLbl val="0"/>
      </c:catAx>
      <c:valAx>
        <c:axId val="17348515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NEFA concentration (mmol/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34851136"/>
        <c:crosses val="autoZero"/>
        <c:crossBetween val="between"/>
      </c:valAx>
      <c:spPr>
        <a:noFill/>
        <a:ln w="25400">
          <a:noFill/>
        </a:ln>
        <a:effectLst/>
      </c:spPr>
    </c:plotArea>
    <c:legend>
      <c:legendPos val="r"/>
      <c:layout>
        <c:manualLayout>
          <c:xMode val="edge"/>
          <c:yMode val="edge"/>
          <c:x val="0.62577886525832738"/>
          <c:y val="0.45526691172518857"/>
          <c:w val="0.16913512382812071"/>
          <c:h val="0.1786097011448712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2" dt="2020-11-17T14:24:04.951" idx="1">
    <p:pos x="3185" y="3988"/>
    <p:text>I have altered this on the basis that there was no treatment*time interaction, and as per their comment for LDL size, we can't look at individual timepoints (symbol missing from graph anyway).</p:text>
    <p:extLst>
      <p:ext uri="{C676402C-5697-4E1C-873F-D02D1690AC5C}">
        <p15:threadingInfo xmlns:p15="http://schemas.microsoft.com/office/powerpoint/2012/main" timeZoneBias="0"/>
      </p:ext>
    </p:extLst>
  </p:cm>
</p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436813" y="1143000"/>
            <a:ext cx="19843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6" name="Google Shape;86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436813" y="1143000"/>
            <a:ext cx="19843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Google Shape;90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1" name="Google Shape;91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436813" y="1143000"/>
            <a:ext cx="19843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8" name="Google Shape;98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436813" y="1143000"/>
            <a:ext cx="19843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Google Shape;107;p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8" name="Google Shape;108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2436813" y="1143000"/>
            <a:ext cx="19843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6"/>
          <p:cNvSpPr txBox="1">
            <a:spLocks noGrp="1"/>
          </p:cNvSpPr>
          <p:nvPr>
            <p:ph type="title"/>
          </p:nvPr>
        </p:nvSpPr>
        <p:spPr>
          <a:xfrm>
            <a:off x="356454" y="429362"/>
            <a:ext cx="4471868" cy="15587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6"/>
          <p:cNvSpPr txBox="1">
            <a:spLocks noGrp="1"/>
          </p:cNvSpPr>
          <p:nvPr>
            <p:ph type="body" idx="1"/>
          </p:nvPr>
        </p:nvSpPr>
        <p:spPr>
          <a:xfrm>
            <a:off x="356454" y="2146800"/>
            <a:ext cx="4471868" cy="51168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5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8" name="Google Shape;18;p6"/>
          <p:cNvSpPr txBox="1">
            <a:spLocks noGrp="1"/>
          </p:cNvSpPr>
          <p:nvPr>
            <p:ph type="dt" idx="10"/>
          </p:nvPr>
        </p:nvSpPr>
        <p:spPr>
          <a:xfrm>
            <a:off x="356453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6"/>
          <p:cNvSpPr txBox="1">
            <a:spLocks noGrp="1"/>
          </p:cNvSpPr>
          <p:nvPr>
            <p:ph type="ftr" idx="11"/>
          </p:nvPr>
        </p:nvSpPr>
        <p:spPr>
          <a:xfrm>
            <a:off x="1717457" y="7474599"/>
            <a:ext cx="1749862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6"/>
          <p:cNvSpPr txBox="1">
            <a:spLocks noGrp="1"/>
          </p:cNvSpPr>
          <p:nvPr>
            <p:ph type="sldNum" idx="12"/>
          </p:nvPr>
        </p:nvSpPr>
        <p:spPr>
          <a:xfrm>
            <a:off x="3661748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5"/>
          <p:cNvSpPr txBox="1">
            <a:spLocks noGrp="1"/>
          </p:cNvSpPr>
          <p:nvPr>
            <p:ph type="title"/>
          </p:nvPr>
        </p:nvSpPr>
        <p:spPr>
          <a:xfrm>
            <a:off x="356454" y="429362"/>
            <a:ext cx="4471868" cy="15587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5"/>
          <p:cNvSpPr txBox="1">
            <a:spLocks noGrp="1"/>
          </p:cNvSpPr>
          <p:nvPr>
            <p:ph type="body" idx="1"/>
          </p:nvPr>
        </p:nvSpPr>
        <p:spPr>
          <a:xfrm rot="5400000">
            <a:off x="33962" y="2469291"/>
            <a:ext cx="5116851" cy="447186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5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5"/>
          <p:cNvSpPr txBox="1">
            <a:spLocks noGrp="1"/>
          </p:cNvSpPr>
          <p:nvPr>
            <p:ph type="dt" idx="10"/>
          </p:nvPr>
        </p:nvSpPr>
        <p:spPr>
          <a:xfrm>
            <a:off x="356453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5"/>
          <p:cNvSpPr txBox="1">
            <a:spLocks noGrp="1"/>
          </p:cNvSpPr>
          <p:nvPr>
            <p:ph type="ftr" idx="11"/>
          </p:nvPr>
        </p:nvSpPr>
        <p:spPr>
          <a:xfrm>
            <a:off x="1717457" y="7474599"/>
            <a:ext cx="1749862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5"/>
          <p:cNvSpPr txBox="1">
            <a:spLocks noGrp="1"/>
          </p:cNvSpPr>
          <p:nvPr>
            <p:ph type="sldNum" idx="12"/>
          </p:nvPr>
        </p:nvSpPr>
        <p:spPr>
          <a:xfrm>
            <a:off x="3661748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6"/>
          <p:cNvSpPr txBox="1">
            <a:spLocks noGrp="1"/>
          </p:cNvSpPr>
          <p:nvPr>
            <p:ph type="title"/>
          </p:nvPr>
        </p:nvSpPr>
        <p:spPr>
          <a:xfrm rot="5400000">
            <a:off x="852193" y="3287522"/>
            <a:ext cx="6834291" cy="11179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6"/>
          <p:cNvSpPr txBox="1">
            <a:spLocks noGrp="1"/>
          </p:cNvSpPr>
          <p:nvPr>
            <p:ph type="body" idx="1"/>
          </p:nvPr>
        </p:nvSpPr>
        <p:spPr>
          <a:xfrm rot="5400000">
            <a:off x="-1416146" y="2201959"/>
            <a:ext cx="6834291" cy="32890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5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6"/>
          <p:cNvSpPr txBox="1">
            <a:spLocks noGrp="1"/>
          </p:cNvSpPr>
          <p:nvPr>
            <p:ph type="dt" idx="10"/>
          </p:nvPr>
        </p:nvSpPr>
        <p:spPr>
          <a:xfrm>
            <a:off x="356453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6"/>
          <p:cNvSpPr txBox="1">
            <a:spLocks noGrp="1"/>
          </p:cNvSpPr>
          <p:nvPr>
            <p:ph type="ftr" idx="11"/>
          </p:nvPr>
        </p:nvSpPr>
        <p:spPr>
          <a:xfrm>
            <a:off x="1717457" y="7474599"/>
            <a:ext cx="1749862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6"/>
          <p:cNvSpPr txBox="1">
            <a:spLocks noGrp="1"/>
          </p:cNvSpPr>
          <p:nvPr>
            <p:ph type="sldNum" idx="12"/>
          </p:nvPr>
        </p:nvSpPr>
        <p:spPr>
          <a:xfrm>
            <a:off x="3661748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7"/>
          <p:cNvSpPr txBox="1">
            <a:spLocks noGrp="1"/>
          </p:cNvSpPr>
          <p:nvPr>
            <p:ph type="ctrTitle"/>
          </p:nvPr>
        </p:nvSpPr>
        <p:spPr>
          <a:xfrm>
            <a:off x="388858" y="1319816"/>
            <a:ext cx="4407059" cy="28076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402"/>
              <a:buFont typeface="Calibri"/>
              <a:buNone/>
              <a:defRPr sz="3402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7"/>
          <p:cNvSpPr txBox="1">
            <a:spLocks noGrp="1"/>
          </p:cNvSpPr>
          <p:nvPr>
            <p:ph type="subTitle" idx="1"/>
          </p:nvPr>
        </p:nvSpPr>
        <p:spPr>
          <a:xfrm>
            <a:off x="648097" y="4235730"/>
            <a:ext cx="3888581" cy="194705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567"/>
              </a:spcBef>
              <a:spcAft>
                <a:spcPts val="0"/>
              </a:spcAft>
              <a:buClr>
                <a:schemeClr val="dk1"/>
              </a:buClr>
              <a:buSzPts val="1361"/>
              <a:buNone/>
              <a:defRPr sz="1361"/>
            </a:lvl1pPr>
            <a:lvl2pPr lvl="1" algn="ctr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134"/>
              <a:buNone/>
              <a:defRPr sz="1134"/>
            </a:lvl2pPr>
            <a:lvl3pPr lvl="2" algn="ctr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021"/>
              <a:buNone/>
              <a:defRPr sz="1021"/>
            </a:lvl3pPr>
            <a:lvl4pPr lvl="3" algn="ctr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/>
            </a:lvl4pPr>
            <a:lvl5pPr lvl="4" algn="ctr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/>
            </a:lvl5pPr>
            <a:lvl6pPr lvl="5" algn="ctr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/>
            </a:lvl6pPr>
            <a:lvl7pPr lvl="6" algn="ctr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/>
            </a:lvl7pPr>
            <a:lvl8pPr lvl="7" algn="ctr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/>
            </a:lvl8pPr>
            <a:lvl9pPr lvl="8" algn="ctr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/>
            </a:lvl9pPr>
          </a:lstStyle>
          <a:p>
            <a:endParaRPr/>
          </a:p>
        </p:txBody>
      </p:sp>
      <p:sp>
        <p:nvSpPr>
          <p:cNvPr id="24" name="Google Shape;24;p7"/>
          <p:cNvSpPr txBox="1">
            <a:spLocks noGrp="1"/>
          </p:cNvSpPr>
          <p:nvPr>
            <p:ph type="dt" idx="10"/>
          </p:nvPr>
        </p:nvSpPr>
        <p:spPr>
          <a:xfrm>
            <a:off x="356453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7"/>
          <p:cNvSpPr txBox="1">
            <a:spLocks noGrp="1"/>
          </p:cNvSpPr>
          <p:nvPr>
            <p:ph type="ftr" idx="11"/>
          </p:nvPr>
        </p:nvSpPr>
        <p:spPr>
          <a:xfrm>
            <a:off x="1717457" y="7474599"/>
            <a:ext cx="1749862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7"/>
          <p:cNvSpPr txBox="1">
            <a:spLocks noGrp="1"/>
          </p:cNvSpPr>
          <p:nvPr>
            <p:ph type="sldNum" idx="12"/>
          </p:nvPr>
        </p:nvSpPr>
        <p:spPr>
          <a:xfrm>
            <a:off x="3661748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8"/>
          <p:cNvSpPr txBox="1">
            <a:spLocks noGrp="1"/>
          </p:cNvSpPr>
          <p:nvPr>
            <p:ph type="title"/>
          </p:nvPr>
        </p:nvSpPr>
        <p:spPr>
          <a:xfrm>
            <a:off x="353753" y="2010527"/>
            <a:ext cx="4471868" cy="33546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402"/>
              <a:buFont typeface="Calibri"/>
              <a:buNone/>
              <a:defRPr sz="3402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8"/>
          <p:cNvSpPr txBox="1">
            <a:spLocks noGrp="1"/>
          </p:cNvSpPr>
          <p:nvPr>
            <p:ph type="body" idx="1"/>
          </p:nvPr>
        </p:nvSpPr>
        <p:spPr>
          <a:xfrm>
            <a:off x="353753" y="5396870"/>
            <a:ext cx="4471868" cy="17641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567"/>
              </a:spcBef>
              <a:spcAft>
                <a:spcPts val="0"/>
              </a:spcAft>
              <a:buClr>
                <a:schemeClr val="dk1"/>
              </a:buClr>
              <a:buSzPts val="1361"/>
              <a:buNone/>
              <a:defRPr sz="1361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rgbClr val="888888"/>
              </a:buClr>
              <a:buSzPts val="1134"/>
              <a:buNone/>
              <a:defRPr sz="1134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rgbClr val="888888"/>
              </a:buClr>
              <a:buSzPts val="1021"/>
              <a:buNone/>
              <a:defRPr sz="1021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rgbClr val="888888"/>
              </a:buClr>
              <a:buSzPts val="907"/>
              <a:buNone/>
              <a:defRPr sz="907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rgbClr val="888888"/>
              </a:buClr>
              <a:buSzPts val="907"/>
              <a:buNone/>
              <a:defRPr sz="907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rgbClr val="888888"/>
              </a:buClr>
              <a:buSzPts val="907"/>
              <a:buNone/>
              <a:defRPr sz="907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rgbClr val="888888"/>
              </a:buClr>
              <a:buSzPts val="907"/>
              <a:buNone/>
              <a:defRPr sz="907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rgbClr val="888888"/>
              </a:buClr>
              <a:buSzPts val="907"/>
              <a:buNone/>
              <a:defRPr sz="907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rgbClr val="888888"/>
              </a:buClr>
              <a:buSzPts val="907"/>
              <a:buNone/>
              <a:defRPr sz="907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8"/>
          <p:cNvSpPr txBox="1">
            <a:spLocks noGrp="1"/>
          </p:cNvSpPr>
          <p:nvPr>
            <p:ph type="dt" idx="10"/>
          </p:nvPr>
        </p:nvSpPr>
        <p:spPr>
          <a:xfrm>
            <a:off x="356453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8"/>
          <p:cNvSpPr txBox="1">
            <a:spLocks noGrp="1"/>
          </p:cNvSpPr>
          <p:nvPr>
            <p:ph type="ftr" idx="11"/>
          </p:nvPr>
        </p:nvSpPr>
        <p:spPr>
          <a:xfrm>
            <a:off x="1717457" y="7474599"/>
            <a:ext cx="1749862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8"/>
          <p:cNvSpPr txBox="1">
            <a:spLocks noGrp="1"/>
          </p:cNvSpPr>
          <p:nvPr>
            <p:ph type="sldNum" idx="12"/>
          </p:nvPr>
        </p:nvSpPr>
        <p:spPr>
          <a:xfrm>
            <a:off x="3661748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9"/>
          <p:cNvSpPr txBox="1">
            <a:spLocks noGrp="1"/>
          </p:cNvSpPr>
          <p:nvPr>
            <p:ph type="title"/>
          </p:nvPr>
        </p:nvSpPr>
        <p:spPr>
          <a:xfrm>
            <a:off x="356454" y="429362"/>
            <a:ext cx="4471868" cy="15587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9"/>
          <p:cNvSpPr txBox="1">
            <a:spLocks noGrp="1"/>
          </p:cNvSpPr>
          <p:nvPr>
            <p:ph type="body" idx="1"/>
          </p:nvPr>
        </p:nvSpPr>
        <p:spPr>
          <a:xfrm>
            <a:off x="356453" y="2146800"/>
            <a:ext cx="2203529" cy="51168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5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9"/>
          <p:cNvSpPr txBox="1">
            <a:spLocks noGrp="1"/>
          </p:cNvSpPr>
          <p:nvPr>
            <p:ph type="body" idx="2"/>
          </p:nvPr>
        </p:nvSpPr>
        <p:spPr>
          <a:xfrm>
            <a:off x="2624793" y="2146800"/>
            <a:ext cx="2203529" cy="51168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5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dt" idx="10"/>
          </p:nvPr>
        </p:nvSpPr>
        <p:spPr>
          <a:xfrm>
            <a:off x="356453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ftr" idx="11"/>
          </p:nvPr>
        </p:nvSpPr>
        <p:spPr>
          <a:xfrm>
            <a:off x="1717457" y="7474599"/>
            <a:ext cx="1749862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sldNum" idx="12"/>
          </p:nvPr>
        </p:nvSpPr>
        <p:spPr>
          <a:xfrm>
            <a:off x="3661748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0"/>
          <p:cNvSpPr txBox="1">
            <a:spLocks noGrp="1"/>
          </p:cNvSpPr>
          <p:nvPr>
            <p:ph type="title"/>
          </p:nvPr>
        </p:nvSpPr>
        <p:spPr>
          <a:xfrm>
            <a:off x="357129" y="429362"/>
            <a:ext cx="4471868" cy="15587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57129" y="1976923"/>
            <a:ext cx="2193403" cy="9688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567"/>
              </a:spcBef>
              <a:spcAft>
                <a:spcPts val="0"/>
              </a:spcAft>
              <a:buClr>
                <a:schemeClr val="dk1"/>
              </a:buClr>
              <a:buSzPts val="1361"/>
              <a:buNone/>
              <a:defRPr sz="1361" b="1"/>
            </a:lvl1pPr>
            <a:lvl2pPr marL="914400" lvl="1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134"/>
              <a:buNone/>
              <a:defRPr sz="1134" b="1"/>
            </a:lvl2pPr>
            <a:lvl3pPr marL="1371600" lvl="2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021"/>
              <a:buNone/>
              <a:defRPr sz="1021" b="1"/>
            </a:lvl3pPr>
            <a:lvl4pPr marL="1828800" lvl="3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 b="1"/>
            </a:lvl4pPr>
            <a:lvl5pPr marL="2286000" lvl="4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 b="1"/>
            </a:lvl5pPr>
            <a:lvl6pPr marL="2743200" lvl="5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 b="1"/>
            </a:lvl6pPr>
            <a:lvl7pPr marL="3200400" lvl="6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 b="1"/>
            </a:lvl7pPr>
            <a:lvl8pPr marL="3657600" lvl="7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 b="1"/>
            </a:lvl8pPr>
            <a:lvl9pPr marL="4114800" lvl="8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 b="1"/>
            </a:lvl9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body" idx="2"/>
          </p:nvPr>
        </p:nvSpPr>
        <p:spPr>
          <a:xfrm>
            <a:off x="357129" y="2945782"/>
            <a:ext cx="2193403" cy="43328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5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0"/>
          <p:cNvSpPr txBox="1">
            <a:spLocks noGrp="1"/>
          </p:cNvSpPr>
          <p:nvPr>
            <p:ph type="body" idx="3"/>
          </p:nvPr>
        </p:nvSpPr>
        <p:spPr>
          <a:xfrm>
            <a:off x="2624792" y="1976923"/>
            <a:ext cx="2204205" cy="9688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567"/>
              </a:spcBef>
              <a:spcAft>
                <a:spcPts val="0"/>
              </a:spcAft>
              <a:buClr>
                <a:schemeClr val="dk1"/>
              </a:buClr>
              <a:buSzPts val="1361"/>
              <a:buNone/>
              <a:defRPr sz="1361" b="1"/>
            </a:lvl1pPr>
            <a:lvl2pPr marL="914400" lvl="1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134"/>
              <a:buNone/>
              <a:defRPr sz="1134" b="1"/>
            </a:lvl2pPr>
            <a:lvl3pPr marL="1371600" lvl="2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021"/>
              <a:buNone/>
              <a:defRPr sz="1021" b="1"/>
            </a:lvl3pPr>
            <a:lvl4pPr marL="1828800" lvl="3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 b="1"/>
            </a:lvl4pPr>
            <a:lvl5pPr marL="2286000" lvl="4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 b="1"/>
            </a:lvl5pPr>
            <a:lvl6pPr marL="2743200" lvl="5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 b="1"/>
            </a:lvl6pPr>
            <a:lvl7pPr marL="3200400" lvl="6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 b="1"/>
            </a:lvl7pPr>
            <a:lvl8pPr marL="3657600" lvl="7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 b="1"/>
            </a:lvl8pPr>
            <a:lvl9pPr marL="4114800" lvl="8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 b="1"/>
            </a:lvl9pPr>
          </a:lstStyle>
          <a:p>
            <a:endParaRPr/>
          </a:p>
        </p:txBody>
      </p:sp>
      <p:sp>
        <p:nvSpPr>
          <p:cNvPr id="45" name="Google Shape;45;p10"/>
          <p:cNvSpPr txBox="1">
            <a:spLocks noGrp="1"/>
          </p:cNvSpPr>
          <p:nvPr>
            <p:ph type="body" idx="4"/>
          </p:nvPr>
        </p:nvSpPr>
        <p:spPr>
          <a:xfrm>
            <a:off x="2624792" y="2945782"/>
            <a:ext cx="2204205" cy="43328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5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0"/>
          <p:cNvSpPr txBox="1">
            <a:spLocks noGrp="1"/>
          </p:cNvSpPr>
          <p:nvPr>
            <p:ph type="dt" idx="10"/>
          </p:nvPr>
        </p:nvSpPr>
        <p:spPr>
          <a:xfrm>
            <a:off x="356453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0"/>
          <p:cNvSpPr txBox="1">
            <a:spLocks noGrp="1"/>
          </p:cNvSpPr>
          <p:nvPr>
            <p:ph type="ftr" idx="11"/>
          </p:nvPr>
        </p:nvSpPr>
        <p:spPr>
          <a:xfrm>
            <a:off x="1717457" y="7474599"/>
            <a:ext cx="1749862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0"/>
          <p:cNvSpPr txBox="1">
            <a:spLocks noGrp="1"/>
          </p:cNvSpPr>
          <p:nvPr>
            <p:ph type="sldNum" idx="12"/>
          </p:nvPr>
        </p:nvSpPr>
        <p:spPr>
          <a:xfrm>
            <a:off x="3661748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1"/>
          <p:cNvSpPr txBox="1">
            <a:spLocks noGrp="1"/>
          </p:cNvSpPr>
          <p:nvPr>
            <p:ph type="title"/>
          </p:nvPr>
        </p:nvSpPr>
        <p:spPr>
          <a:xfrm>
            <a:off x="356454" y="429362"/>
            <a:ext cx="4471868" cy="15587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1"/>
          <p:cNvSpPr txBox="1">
            <a:spLocks noGrp="1"/>
          </p:cNvSpPr>
          <p:nvPr>
            <p:ph type="dt" idx="10"/>
          </p:nvPr>
        </p:nvSpPr>
        <p:spPr>
          <a:xfrm>
            <a:off x="356453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1"/>
          <p:cNvSpPr txBox="1">
            <a:spLocks noGrp="1"/>
          </p:cNvSpPr>
          <p:nvPr>
            <p:ph type="ftr" idx="11"/>
          </p:nvPr>
        </p:nvSpPr>
        <p:spPr>
          <a:xfrm>
            <a:off x="1717457" y="7474599"/>
            <a:ext cx="1749862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1"/>
          <p:cNvSpPr txBox="1">
            <a:spLocks noGrp="1"/>
          </p:cNvSpPr>
          <p:nvPr>
            <p:ph type="sldNum" idx="12"/>
          </p:nvPr>
        </p:nvSpPr>
        <p:spPr>
          <a:xfrm>
            <a:off x="3661748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2"/>
          <p:cNvSpPr txBox="1">
            <a:spLocks noGrp="1"/>
          </p:cNvSpPr>
          <p:nvPr>
            <p:ph type="dt" idx="10"/>
          </p:nvPr>
        </p:nvSpPr>
        <p:spPr>
          <a:xfrm>
            <a:off x="356453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2"/>
          <p:cNvSpPr txBox="1">
            <a:spLocks noGrp="1"/>
          </p:cNvSpPr>
          <p:nvPr>
            <p:ph type="ftr" idx="11"/>
          </p:nvPr>
        </p:nvSpPr>
        <p:spPr>
          <a:xfrm>
            <a:off x="1717457" y="7474599"/>
            <a:ext cx="1749862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2"/>
          <p:cNvSpPr txBox="1">
            <a:spLocks noGrp="1"/>
          </p:cNvSpPr>
          <p:nvPr>
            <p:ph type="sldNum" idx="12"/>
          </p:nvPr>
        </p:nvSpPr>
        <p:spPr>
          <a:xfrm>
            <a:off x="3661748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3"/>
          <p:cNvSpPr txBox="1">
            <a:spLocks noGrp="1"/>
          </p:cNvSpPr>
          <p:nvPr>
            <p:ph type="title"/>
          </p:nvPr>
        </p:nvSpPr>
        <p:spPr>
          <a:xfrm>
            <a:off x="357129" y="537633"/>
            <a:ext cx="1672225" cy="18817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14"/>
              <a:buFont typeface="Calibri"/>
              <a:buNone/>
              <a:defRPr sz="1814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3"/>
          <p:cNvSpPr txBox="1">
            <a:spLocks noGrp="1"/>
          </p:cNvSpPr>
          <p:nvPr>
            <p:ph type="body" idx="1"/>
          </p:nvPr>
        </p:nvSpPr>
        <p:spPr>
          <a:xfrm>
            <a:off x="2204205" y="1161140"/>
            <a:ext cx="2624792" cy="57310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3789" algn="l">
              <a:lnSpc>
                <a:spcPct val="90000"/>
              </a:lnSpc>
              <a:spcBef>
                <a:spcPts val="567"/>
              </a:spcBef>
              <a:spcAft>
                <a:spcPts val="0"/>
              </a:spcAft>
              <a:buClr>
                <a:schemeClr val="dk1"/>
              </a:buClr>
              <a:buSzPts val="1814"/>
              <a:buChar char="•"/>
              <a:defRPr sz="1814"/>
            </a:lvl1pPr>
            <a:lvl2pPr marL="914400" lvl="1" indent="-329437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588"/>
              <a:buChar char="•"/>
              <a:defRPr sz="1588"/>
            </a:lvl2pPr>
            <a:lvl3pPr marL="1371600" lvl="2" indent="-315023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361"/>
              <a:buChar char="•"/>
              <a:defRPr sz="1361"/>
            </a:lvl3pPr>
            <a:lvl4pPr marL="1828800" lvl="3" indent="-300608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134"/>
              <a:buChar char="•"/>
              <a:defRPr sz="1134"/>
            </a:lvl4pPr>
            <a:lvl5pPr marL="2286000" lvl="4" indent="-300608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134"/>
              <a:buChar char="•"/>
              <a:defRPr sz="1134"/>
            </a:lvl5pPr>
            <a:lvl6pPr marL="2743200" lvl="5" indent="-300608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134"/>
              <a:buChar char="•"/>
              <a:defRPr sz="1134"/>
            </a:lvl6pPr>
            <a:lvl7pPr marL="3200400" lvl="6" indent="-300608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134"/>
              <a:buChar char="•"/>
              <a:defRPr sz="1134"/>
            </a:lvl7pPr>
            <a:lvl8pPr marL="3657600" lvl="7" indent="-300609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134"/>
              <a:buChar char="•"/>
              <a:defRPr sz="1134"/>
            </a:lvl8pPr>
            <a:lvl9pPr marL="4114800" lvl="8" indent="-300609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134"/>
              <a:buChar char="•"/>
              <a:defRPr sz="1134"/>
            </a:lvl9pPr>
          </a:lstStyle>
          <a:p>
            <a:endParaRPr/>
          </a:p>
        </p:txBody>
      </p:sp>
      <p:sp>
        <p:nvSpPr>
          <p:cNvPr id="61" name="Google Shape;61;p13"/>
          <p:cNvSpPr txBox="1">
            <a:spLocks noGrp="1"/>
          </p:cNvSpPr>
          <p:nvPr>
            <p:ph type="body" idx="2"/>
          </p:nvPr>
        </p:nvSpPr>
        <p:spPr>
          <a:xfrm>
            <a:off x="357129" y="2419350"/>
            <a:ext cx="1672225" cy="448214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567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/>
            </a:lvl1pPr>
            <a:lvl2pPr marL="914400" lvl="1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794"/>
              <a:buNone/>
              <a:defRPr sz="794"/>
            </a:lvl2pPr>
            <a:lvl3pPr marL="1371600" lvl="2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680"/>
              <a:buNone/>
              <a:defRPr sz="680"/>
            </a:lvl3pPr>
            <a:lvl4pPr marL="1828800" lvl="3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567"/>
              <a:buNone/>
              <a:defRPr sz="567"/>
            </a:lvl4pPr>
            <a:lvl5pPr marL="2286000" lvl="4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567"/>
              <a:buNone/>
              <a:defRPr sz="567"/>
            </a:lvl5pPr>
            <a:lvl6pPr marL="2743200" lvl="5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567"/>
              <a:buNone/>
              <a:defRPr sz="567"/>
            </a:lvl6pPr>
            <a:lvl7pPr marL="3200400" lvl="6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567"/>
              <a:buNone/>
              <a:defRPr sz="567"/>
            </a:lvl7pPr>
            <a:lvl8pPr marL="3657600" lvl="7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567"/>
              <a:buNone/>
              <a:defRPr sz="567"/>
            </a:lvl8pPr>
            <a:lvl9pPr marL="4114800" lvl="8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567"/>
              <a:buNone/>
              <a:defRPr sz="567"/>
            </a:lvl9pPr>
          </a:lstStyle>
          <a:p>
            <a:endParaRPr/>
          </a:p>
        </p:txBody>
      </p:sp>
      <p:sp>
        <p:nvSpPr>
          <p:cNvPr id="62" name="Google Shape;62;p13"/>
          <p:cNvSpPr txBox="1">
            <a:spLocks noGrp="1"/>
          </p:cNvSpPr>
          <p:nvPr>
            <p:ph type="dt" idx="10"/>
          </p:nvPr>
        </p:nvSpPr>
        <p:spPr>
          <a:xfrm>
            <a:off x="356453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3"/>
          <p:cNvSpPr txBox="1">
            <a:spLocks noGrp="1"/>
          </p:cNvSpPr>
          <p:nvPr>
            <p:ph type="ftr" idx="11"/>
          </p:nvPr>
        </p:nvSpPr>
        <p:spPr>
          <a:xfrm>
            <a:off x="1717457" y="7474599"/>
            <a:ext cx="1749862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3"/>
          <p:cNvSpPr txBox="1">
            <a:spLocks noGrp="1"/>
          </p:cNvSpPr>
          <p:nvPr>
            <p:ph type="sldNum" idx="12"/>
          </p:nvPr>
        </p:nvSpPr>
        <p:spPr>
          <a:xfrm>
            <a:off x="3661748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4"/>
          <p:cNvSpPr txBox="1">
            <a:spLocks noGrp="1"/>
          </p:cNvSpPr>
          <p:nvPr>
            <p:ph type="title"/>
          </p:nvPr>
        </p:nvSpPr>
        <p:spPr>
          <a:xfrm>
            <a:off x="357129" y="537633"/>
            <a:ext cx="1672225" cy="18817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14"/>
              <a:buFont typeface="Calibri"/>
              <a:buNone/>
              <a:defRPr sz="1814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4"/>
          <p:cNvSpPr>
            <a:spLocks noGrp="1"/>
          </p:cNvSpPr>
          <p:nvPr>
            <p:ph type="pic" idx="2"/>
          </p:nvPr>
        </p:nvSpPr>
        <p:spPr>
          <a:xfrm>
            <a:off x="2204205" y="1161140"/>
            <a:ext cx="2624792" cy="57310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567"/>
              </a:spcBef>
              <a:spcAft>
                <a:spcPts val="0"/>
              </a:spcAft>
              <a:buClr>
                <a:schemeClr val="dk1"/>
              </a:buClr>
              <a:buSzPts val="1814"/>
              <a:buFont typeface="Arial"/>
              <a:buNone/>
              <a:defRPr sz="181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588"/>
              <a:buFont typeface="Arial"/>
              <a:buNone/>
              <a:defRPr sz="158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361"/>
              <a:buFont typeface="Arial"/>
              <a:buNone/>
              <a:defRPr sz="13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134"/>
              <a:buFont typeface="Arial"/>
              <a:buNone/>
              <a:defRPr sz="113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134"/>
              <a:buFont typeface="Arial"/>
              <a:buNone/>
              <a:defRPr sz="113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134"/>
              <a:buFont typeface="Arial"/>
              <a:buNone/>
              <a:defRPr sz="113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134"/>
              <a:buFont typeface="Arial"/>
              <a:buNone/>
              <a:defRPr sz="113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134"/>
              <a:buFont typeface="Arial"/>
              <a:buNone/>
              <a:defRPr sz="113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134"/>
              <a:buFont typeface="Arial"/>
              <a:buNone/>
              <a:defRPr sz="113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8" name="Google Shape;68;p14"/>
          <p:cNvSpPr txBox="1">
            <a:spLocks noGrp="1"/>
          </p:cNvSpPr>
          <p:nvPr>
            <p:ph type="body" idx="1"/>
          </p:nvPr>
        </p:nvSpPr>
        <p:spPr>
          <a:xfrm>
            <a:off x="357129" y="2419350"/>
            <a:ext cx="1672225" cy="448214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567"/>
              </a:spcBef>
              <a:spcAft>
                <a:spcPts val="0"/>
              </a:spcAft>
              <a:buClr>
                <a:schemeClr val="dk1"/>
              </a:buClr>
              <a:buSzPts val="907"/>
              <a:buNone/>
              <a:defRPr sz="907"/>
            </a:lvl1pPr>
            <a:lvl2pPr marL="914400" lvl="1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794"/>
              <a:buNone/>
              <a:defRPr sz="794"/>
            </a:lvl2pPr>
            <a:lvl3pPr marL="1371600" lvl="2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680"/>
              <a:buNone/>
              <a:defRPr sz="680"/>
            </a:lvl3pPr>
            <a:lvl4pPr marL="1828800" lvl="3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567"/>
              <a:buNone/>
              <a:defRPr sz="567"/>
            </a:lvl4pPr>
            <a:lvl5pPr marL="2286000" lvl="4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567"/>
              <a:buNone/>
              <a:defRPr sz="567"/>
            </a:lvl5pPr>
            <a:lvl6pPr marL="2743200" lvl="5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567"/>
              <a:buNone/>
              <a:defRPr sz="567"/>
            </a:lvl6pPr>
            <a:lvl7pPr marL="3200400" lvl="6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567"/>
              <a:buNone/>
              <a:defRPr sz="567"/>
            </a:lvl7pPr>
            <a:lvl8pPr marL="3657600" lvl="7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567"/>
              <a:buNone/>
              <a:defRPr sz="567"/>
            </a:lvl8pPr>
            <a:lvl9pPr marL="4114800" lvl="8" indent="-228600" algn="l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567"/>
              <a:buNone/>
              <a:defRPr sz="567"/>
            </a:lvl9pPr>
          </a:lstStyle>
          <a:p>
            <a:endParaRPr/>
          </a:p>
        </p:txBody>
      </p:sp>
      <p:sp>
        <p:nvSpPr>
          <p:cNvPr id="69" name="Google Shape;69;p14"/>
          <p:cNvSpPr txBox="1">
            <a:spLocks noGrp="1"/>
          </p:cNvSpPr>
          <p:nvPr>
            <p:ph type="dt" idx="10"/>
          </p:nvPr>
        </p:nvSpPr>
        <p:spPr>
          <a:xfrm>
            <a:off x="356453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4"/>
          <p:cNvSpPr txBox="1">
            <a:spLocks noGrp="1"/>
          </p:cNvSpPr>
          <p:nvPr>
            <p:ph type="ftr" idx="11"/>
          </p:nvPr>
        </p:nvSpPr>
        <p:spPr>
          <a:xfrm>
            <a:off x="1717457" y="7474599"/>
            <a:ext cx="1749862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4"/>
          <p:cNvSpPr txBox="1">
            <a:spLocks noGrp="1"/>
          </p:cNvSpPr>
          <p:nvPr>
            <p:ph type="sldNum" idx="12"/>
          </p:nvPr>
        </p:nvSpPr>
        <p:spPr>
          <a:xfrm>
            <a:off x="3661748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5"/>
          <p:cNvSpPr txBox="1">
            <a:spLocks noGrp="1"/>
          </p:cNvSpPr>
          <p:nvPr>
            <p:ph type="title"/>
          </p:nvPr>
        </p:nvSpPr>
        <p:spPr>
          <a:xfrm>
            <a:off x="356454" y="429362"/>
            <a:ext cx="4471868" cy="15587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95"/>
              <a:buFont typeface="Calibri"/>
              <a:buNone/>
              <a:defRPr sz="249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5"/>
          <p:cNvSpPr txBox="1">
            <a:spLocks noGrp="1"/>
          </p:cNvSpPr>
          <p:nvPr>
            <p:ph type="body" idx="1"/>
          </p:nvPr>
        </p:nvSpPr>
        <p:spPr>
          <a:xfrm>
            <a:off x="356454" y="2146800"/>
            <a:ext cx="4471868" cy="51168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29438" algn="l" rtl="0">
              <a:lnSpc>
                <a:spcPct val="90000"/>
              </a:lnSpc>
              <a:spcBef>
                <a:spcPts val="567"/>
              </a:spcBef>
              <a:spcAft>
                <a:spcPts val="0"/>
              </a:spcAft>
              <a:buClr>
                <a:schemeClr val="dk1"/>
              </a:buClr>
              <a:buSzPts val="1588"/>
              <a:buFont typeface="Arial"/>
              <a:buChar char="•"/>
              <a:defRPr sz="158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15023" algn="l" rtl="0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361"/>
              <a:buFont typeface="Arial"/>
              <a:buChar char="•"/>
              <a:defRPr sz="13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00608" algn="l" rtl="0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134"/>
              <a:buFont typeface="Arial"/>
              <a:buChar char="•"/>
              <a:defRPr sz="113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93433" algn="l" rtl="0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021"/>
              <a:buFont typeface="Arial"/>
              <a:buChar char="•"/>
              <a:defRPr sz="102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93433" algn="l" rtl="0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021"/>
              <a:buFont typeface="Arial"/>
              <a:buChar char="•"/>
              <a:defRPr sz="102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93433" algn="l" rtl="0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021"/>
              <a:buFont typeface="Arial"/>
              <a:buChar char="•"/>
              <a:defRPr sz="102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93433" algn="l" rtl="0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021"/>
              <a:buFont typeface="Arial"/>
              <a:buChar char="•"/>
              <a:defRPr sz="102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93433" algn="l" rtl="0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021"/>
              <a:buFont typeface="Arial"/>
              <a:buChar char="•"/>
              <a:defRPr sz="102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93433" algn="l" rtl="0">
              <a:lnSpc>
                <a:spcPct val="90000"/>
              </a:lnSpc>
              <a:spcBef>
                <a:spcPts val="284"/>
              </a:spcBef>
              <a:spcAft>
                <a:spcPts val="0"/>
              </a:spcAft>
              <a:buClr>
                <a:schemeClr val="dk1"/>
              </a:buClr>
              <a:buSzPts val="1021"/>
              <a:buFont typeface="Arial"/>
              <a:buChar char="•"/>
              <a:defRPr sz="102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5"/>
          <p:cNvSpPr txBox="1">
            <a:spLocks noGrp="1"/>
          </p:cNvSpPr>
          <p:nvPr>
            <p:ph type="dt" idx="10"/>
          </p:nvPr>
        </p:nvSpPr>
        <p:spPr>
          <a:xfrm>
            <a:off x="356453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68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5"/>
          <p:cNvSpPr txBox="1">
            <a:spLocks noGrp="1"/>
          </p:cNvSpPr>
          <p:nvPr>
            <p:ph type="ftr" idx="11"/>
          </p:nvPr>
        </p:nvSpPr>
        <p:spPr>
          <a:xfrm>
            <a:off x="1717457" y="7474599"/>
            <a:ext cx="1749862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68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5"/>
          <p:cNvSpPr txBox="1">
            <a:spLocks noGrp="1"/>
          </p:cNvSpPr>
          <p:nvPr>
            <p:ph type="sldNum" idx="12"/>
          </p:nvPr>
        </p:nvSpPr>
        <p:spPr>
          <a:xfrm>
            <a:off x="3661748" y="7474599"/>
            <a:ext cx="1166574" cy="42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68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68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68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68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68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68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68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68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68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comments" Target="../comments/commen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Google Shape;88;p1"/>
          <p:cNvSpPr txBox="1"/>
          <p:nvPr/>
        </p:nvSpPr>
        <p:spPr>
          <a:xfrm>
            <a:off x="-1" y="0"/>
            <a:ext cx="5184775" cy="501675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nline Supplementary Material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almitic acid-rich oils with and without interesterification lower postprandial lipemia and increase atherogenic lipoproteins compared to a MUFA-rich oil: A randomized controlled trial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 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arlotte E Mills</a:t>
            </a:r>
            <a:r>
              <a:rPr lang="en-GB" sz="140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,2</a:t>
            </a:r>
            <a:r>
              <a:rPr lang="en-GB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, Scott V Harding</a:t>
            </a:r>
            <a:r>
              <a:rPr lang="en-GB" sz="140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r>
              <a:rPr lang="en-GB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, Mariam Bapir</a:t>
            </a:r>
            <a:r>
              <a:rPr lang="en-GB" sz="140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r>
              <a:rPr lang="en-GB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, Giuseppina Mandalari</a:t>
            </a:r>
            <a:r>
              <a:rPr lang="en-GB" sz="140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,5</a:t>
            </a:r>
            <a:r>
              <a:rPr lang="en-GB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, Louise J Salt</a:t>
            </a:r>
            <a:r>
              <a:rPr lang="en-GB" sz="140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r>
              <a:rPr lang="en-GB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, Robert Gray</a:t>
            </a:r>
            <a:r>
              <a:rPr lang="en-GB" sz="140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r>
              <a:rPr lang="en-GB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, Barbara A Fielding</a:t>
            </a:r>
            <a:r>
              <a:rPr lang="en-GB" sz="140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</a:t>
            </a:r>
            <a:r>
              <a:rPr lang="en-GB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, Peter J. Wilde</a:t>
            </a:r>
            <a:r>
              <a:rPr lang="en-GB" sz="140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r>
              <a:rPr lang="en-GB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, Wendy L Hall</a:t>
            </a:r>
            <a:r>
              <a:rPr lang="en-GB" sz="140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r>
              <a:rPr lang="en-GB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, Sarah E Berry</a:t>
            </a:r>
            <a:r>
              <a:rPr lang="en-GB" sz="140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 </a:t>
            </a:r>
            <a:r>
              <a:rPr lang="en-GB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epartment of Nutritional Sciences, School of Life Course Sciences, Faculty of Life Sciences &amp; Medicine, King’s College London, UK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 </a:t>
            </a:r>
            <a:r>
              <a:rPr lang="en-GB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epartment of Food and Nutritional Sciences, University of Reading, UK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r>
              <a:rPr lang="en-GB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Department of Biochemistry, Memorial University of Newfoundland, Canada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r>
              <a:rPr lang="en-GB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Food Innovation and Health Programme, Quadram Institute Bioscience, UK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r>
              <a:rPr lang="en-GB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Department of Chemical, Biological, Pharmaceutical and Environmental Science, University of Messina, Messina, Italy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</a:t>
            </a:r>
            <a:r>
              <a:rPr lang="en-GB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Department of Nutritional Sciences, University of Surrey, UK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3" name="Google Shape;93;p2" descr="A screenshot of a cell phone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2071" y="801756"/>
            <a:ext cx="5186846" cy="4273828"/>
          </a:xfrm>
          <a:prstGeom prst="rect">
            <a:avLst/>
          </a:prstGeom>
          <a:noFill/>
          <a:ln>
            <a:noFill/>
          </a:ln>
        </p:spPr>
      </p:pic>
      <p:sp>
        <p:nvSpPr>
          <p:cNvPr id="94" name="Google Shape;94;p2"/>
          <p:cNvSpPr txBox="1"/>
          <p:nvPr/>
        </p:nvSpPr>
        <p:spPr>
          <a:xfrm>
            <a:off x="0" y="0"/>
            <a:ext cx="241886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1</a:t>
            </a:r>
            <a:endParaRPr/>
          </a:p>
        </p:txBody>
      </p:sp>
      <p:sp>
        <p:nvSpPr>
          <p:cNvPr id="95" name="Google Shape;95;p2"/>
          <p:cNvSpPr/>
          <p:nvPr/>
        </p:nvSpPr>
        <p:spPr>
          <a:xfrm>
            <a:off x="551" y="5370931"/>
            <a:ext cx="5184223" cy="66075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1. </a:t>
            </a:r>
            <a:r>
              <a:rPr lang="en-GB" sz="10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ONSORT flow diagram showing progression of participants through the Inter-Met study</a:t>
            </a:r>
            <a:endParaRPr sz="100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A4E534F8-1AB1-B54C-A56C-47C66D10A148}"/>
              </a:ext>
            </a:extLst>
          </p:cNvPr>
          <p:cNvSpPr/>
          <p:nvPr/>
        </p:nvSpPr>
        <p:spPr>
          <a:xfrm>
            <a:off x="1" y="3730172"/>
            <a:ext cx="5184774" cy="26107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200000"/>
              </a:lnSpc>
            </a:pPr>
            <a:r>
              <a:rPr lang="en-GB" b="1" dirty="0">
                <a:solidFill>
                  <a:schemeClr val="dk1"/>
                </a:solidFill>
              </a:rPr>
              <a:t>Supplementary Figure 2.</a:t>
            </a:r>
            <a:r>
              <a:rPr lang="en-GB" dirty="0">
                <a:solidFill>
                  <a:schemeClr val="dk1"/>
                </a:solidFill>
              </a:rPr>
              <a:t> The effect of an </a:t>
            </a:r>
            <a:r>
              <a:rPr lang="en-GB" dirty="0" err="1">
                <a:solidFill>
                  <a:schemeClr val="dk1"/>
                </a:solidFill>
              </a:rPr>
              <a:t>interesterified</a:t>
            </a:r>
            <a:r>
              <a:rPr lang="en-GB" dirty="0">
                <a:solidFill>
                  <a:schemeClr val="dk1"/>
                </a:solidFill>
              </a:rPr>
              <a:t> (IE) palm stearin/palm kernel (</a:t>
            </a:r>
            <a:r>
              <a:rPr lang="en-GB" dirty="0" err="1">
                <a:solidFill>
                  <a:schemeClr val="dk1"/>
                </a:solidFill>
              </a:rPr>
              <a:t>PSt</a:t>
            </a:r>
            <a:r>
              <a:rPr lang="en-GB" dirty="0">
                <a:solidFill>
                  <a:schemeClr val="dk1"/>
                </a:solidFill>
              </a:rPr>
              <a:t>/PK) fat, non-</a:t>
            </a:r>
            <a:r>
              <a:rPr lang="en-GB" dirty="0" err="1">
                <a:solidFill>
                  <a:schemeClr val="dk1"/>
                </a:solidFill>
              </a:rPr>
              <a:t>interesterified</a:t>
            </a:r>
            <a:r>
              <a:rPr lang="en-GB" dirty="0">
                <a:solidFill>
                  <a:schemeClr val="dk1"/>
                </a:solidFill>
              </a:rPr>
              <a:t> palm stearin/palm kernel (</a:t>
            </a:r>
            <a:r>
              <a:rPr lang="en-GB" dirty="0" err="1">
                <a:solidFill>
                  <a:schemeClr val="dk1"/>
                </a:solidFill>
              </a:rPr>
              <a:t>PSt</a:t>
            </a:r>
            <a:r>
              <a:rPr lang="en-GB" dirty="0">
                <a:solidFill>
                  <a:schemeClr val="dk1"/>
                </a:solidFill>
              </a:rPr>
              <a:t>/PK) fat and reference MUFA on postprandial plasma non-esterified fatty acid (NEFA). Data are mean (SEM), n=20. Linear mixed model analysis revealed no treatment effect.</a:t>
            </a:r>
            <a:endParaRPr lang="en-GB" dirty="0">
              <a:solidFill>
                <a:srgbClr val="FF0000"/>
              </a:solidFill>
            </a:endParaRP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1B11F745-77A1-7945-81B4-1F6F65DBFE57}"/>
              </a:ext>
            </a:extLst>
          </p:cNvPr>
          <p:cNvCxnSpPr>
            <a:cxnSpLocks/>
          </p:cNvCxnSpPr>
          <p:nvPr/>
        </p:nvCxnSpPr>
        <p:spPr>
          <a:xfrm>
            <a:off x="720131" y="844731"/>
            <a:ext cx="0" cy="2344281"/>
          </a:xfrm>
          <a:prstGeom prst="line">
            <a:avLst/>
          </a:prstGeom>
          <a:ln>
            <a:solidFill>
              <a:schemeClr val="tx2">
                <a:lumMod val="9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Google Shape;110;p4">
            <a:extLst>
              <a:ext uri="{FF2B5EF4-FFF2-40B4-BE49-F238E27FC236}">
                <a16:creationId xmlns:a16="http://schemas.microsoft.com/office/drawing/2014/main" id="{83773F5D-EBAD-054C-B3BF-AD9FD1E1A1E4}"/>
              </a:ext>
            </a:extLst>
          </p:cNvPr>
          <p:cNvSpPr txBox="1"/>
          <p:nvPr/>
        </p:nvSpPr>
        <p:spPr>
          <a:xfrm>
            <a:off x="0" y="0"/>
            <a:ext cx="241886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2</a:t>
            </a:r>
            <a:endParaRPr dirty="0"/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C6877C83-1B7D-C24F-AF83-34759549F34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4226571"/>
              </p:ext>
            </p:extLst>
          </p:nvPr>
        </p:nvGraphicFramePr>
        <p:xfrm>
          <a:off x="-480242" y="781973"/>
          <a:ext cx="6754859" cy="33306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0767268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Google Shape;105;p3"/>
          <p:cNvSpPr/>
          <p:nvPr/>
        </p:nvSpPr>
        <p:spPr>
          <a:xfrm>
            <a:off x="-62" y="4281055"/>
            <a:ext cx="5184900" cy="31085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1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3.</a:t>
            </a:r>
            <a:r>
              <a:rPr lang="en-GB" sz="11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The effect of an </a:t>
            </a:r>
            <a:r>
              <a:rPr lang="en-GB" sz="11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nteresterified</a:t>
            </a:r>
            <a:r>
              <a:rPr lang="en-GB" sz="11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(IE) palm stearin/palm kernel (</a:t>
            </a:r>
            <a:r>
              <a:rPr lang="en-GB" sz="11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St</a:t>
            </a:r>
            <a:r>
              <a:rPr lang="en-GB" sz="11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/PK) fat on postprandial plasma A) palmitic acid (16:0), B) stearic acid (18:0), C) oleic acid (18:1n-9) and D) linoleic acid (18:2n-6) concentrations relative to a non-IE equivalent and a reference rapeseed oil. Data are mean (SEM), n=20. Post hoc analysis of time-point differences with Bonferroni adjustment showed </a:t>
            </a:r>
            <a:r>
              <a:rPr lang="en-GB" sz="1100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significant differences between both IE and non-IE fats vs RO at 3-8 h for 16:0, 18:0 and 18:0n-9: * </a:t>
            </a:r>
            <a:r>
              <a:rPr lang="en-GB" sz="1100" i="1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P</a:t>
            </a:r>
            <a:r>
              <a:rPr lang="en-GB" sz="1100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&lt;0.05-0.0001. </a:t>
            </a:r>
            <a:r>
              <a:rPr lang="en-GB" sz="1100" dirty="0">
                <a:solidFill>
                  <a:schemeClr val="tx1"/>
                </a:solidFill>
                <a:highlight>
                  <a:srgbClr val="FFFF00"/>
                </a:highlight>
                <a:latin typeface="Arial"/>
                <a:ea typeface="Arial"/>
                <a:cs typeface="Arial"/>
                <a:sym typeface="Arial"/>
              </a:rPr>
              <a:t>Significant </a:t>
            </a:r>
            <a:r>
              <a:rPr lang="en-GB" sz="1100">
                <a:solidFill>
                  <a:schemeClr val="tx1"/>
                </a:solidFill>
                <a:highlight>
                  <a:srgbClr val="FFFF00"/>
                </a:highlight>
                <a:latin typeface="Arial"/>
                <a:ea typeface="Arial"/>
                <a:cs typeface="Arial"/>
                <a:sym typeface="Arial"/>
              </a:rPr>
              <a:t>treatment difference </a:t>
            </a:r>
            <a:r>
              <a:rPr lang="en-GB" sz="1100" dirty="0">
                <a:solidFill>
                  <a:schemeClr val="tx1"/>
                </a:solidFill>
                <a:highlight>
                  <a:srgbClr val="FFFF00"/>
                </a:highlight>
                <a:latin typeface="Arial"/>
                <a:ea typeface="Arial"/>
                <a:cs typeface="Arial"/>
                <a:sym typeface="Arial"/>
              </a:rPr>
              <a:t>between IE and non-IE fats for 16:0</a:t>
            </a:r>
            <a:r>
              <a:rPr lang="en-GB" sz="1100" dirty="0">
                <a:solidFill>
                  <a:schemeClr val="tx1"/>
                </a:solidFill>
                <a:highlight>
                  <a:srgbClr val="FFFF00"/>
                </a:highlight>
              </a:rPr>
              <a:t> (</a:t>
            </a:r>
            <a:r>
              <a:rPr lang="en-GB" sz="1100" i="1" dirty="0">
                <a:solidFill>
                  <a:schemeClr val="tx1"/>
                </a:solidFill>
                <a:highlight>
                  <a:srgbClr val="FFFF00"/>
                </a:highlight>
              </a:rPr>
              <a:t>P &lt;</a:t>
            </a:r>
            <a:r>
              <a:rPr lang="en-GB" sz="1100">
                <a:solidFill>
                  <a:schemeClr val="tx1"/>
                </a:solidFill>
                <a:highlight>
                  <a:srgbClr val="FFFF00"/>
                </a:highlight>
              </a:rPr>
              <a:t>0.05).</a:t>
            </a:r>
            <a:endParaRPr sz="1100" dirty="0">
              <a:solidFill>
                <a:schemeClr val="tx1"/>
              </a:solidFill>
              <a:highlight>
                <a:srgbClr val="FFFF00"/>
              </a:highlight>
            </a:endParaRPr>
          </a:p>
          <a:p>
            <a:pPr marL="0" marR="0" lvl="0" indent="0" algn="l" rtl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000" dirty="0">
              <a:solidFill>
                <a:schemeClr val="dk1"/>
              </a:solidFill>
            </a:endParaRPr>
          </a:p>
        </p:txBody>
      </p:sp>
      <p:pic>
        <p:nvPicPr>
          <p:cNvPr id="8" name="Picture 3" descr="A close up of a piece of paper&#10;&#10;Description generated with high confidence">
            <a:extLst>
              <a:ext uri="{FF2B5EF4-FFF2-40B4-BE49-F238E27FC236}">
                <a16:creationId xmlns:a16="http://schemas.microsoft.com/office/drawing/2014/main" id="{2DE8CD5A-CB0E-EA48-90BD-C2BF04071B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62" y="369332"/>
            <a:ext cx="5016221" cy="3911723"/>
          </a:xfrm>
          <a:prstGeom prst="rect">
            <a:avLst/>
          </a:prstGeom>
        </p:spPr>
      </p:pic>
      <p:sp>
        <p:nvSpPr>
          <p:cNvPr id="9" name="Google Shape;110;p4">
            <a:extLst>
              <a:ext uri="{FF2B5EF4-FFF2-40B4-BE49-F238E27FC236}">
                <a16:creationId xmlns:a16="http://schemas.microsoft.com/office/drawing/2014/main" id="{FD358D0C-60FE-9649-833C-924ACC62742D}"/>
              </a:ext>
            </a:extLst>
          </p:cNvPr>
          <p:cNvSpPr txBox="1"/>
          <p:nvPr/>
        </p:nvSpPr>
        <p:spPr>
          <a:xfrm>
            <a:off x="0" y="0"/>
            <a:ext cx="241886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3</a:t>
            </a:r>
            <a:endParaRPr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72090D9-BE91-2347-BEDB-1B8945DFECF1}"/>
              </a:ext>
            </a:extLst>
          </p:cNvPr>
          <p:cNvSpPr txBox="1"/>
          <p:nvPr/>
        </p:nvSpPr>
        <p:spPr>
          <a:xfrm>
            <a:off x="33803" y="369332"/>
            <a:ext cx="269626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81070EC-D9D3-A246-8FFD-BEB394B97987}"/>
              </a:ext>
            </a:extLst>
          </p:cNvPr>
          <p:cNvSpPr txBox="1"/>
          <p:nvPr/>
        </p:nvSpPr>
        <p:spPr>
          <a:xfrm>
            <a:off x="2592387" y="369332"/>
            <a:ext cx="269626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dirty="0"/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8724A39-4FA5-1349-A54F-945598443983}"/>
              </a:ext>
            </a:extLst>
          </p:cNvPr>
          <p:cNvSpPr txBox="1"/>
          <p:nvPr/>
        </p:nvSpPr>
        <p:spPr>
          <a:xfrm>
            <a:off x="33803" y="2224846"/>
            <a:ext cx="27764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dirty="0"/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CF5B433-C6BA-8845-8A4F-556897843232}"/>
              </a:ext>
            </a:extLst>
          </p:cNvPr>
          <p:cNvSpPr txBox="1"/>
          <p:nvPr/>
        </p:nvSpPr>
        <p:spPr>
          <a:xfrm>
            <a:off x="2592387" y="2212181"/>
            <a:ext cx="27764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dirty="0"/>
              <a:t>D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Google Shape;110;p4"/>
          <p:cNvSpPr txBox="1"/>
          <p:nvPr/>
        </p:nvSpPr>
        <p:spPr>
          <a:xfrm>
            <a:off x="0" y="0"/>
            <a:ext cx="241886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4</a:t>
            </a:r>
            <a:endParaRPr dirty="0"/>
          </a:p>
        </p:txBody>
      </p:sp>
      <p:pic>
        <p:nvPicPr>
          <p:cNvPr id="111" name="Google Shape;111;p4"/>
          <p:cNvPicPr preferRelativeResize="0"/>
          <p:nvPr/>
        </p:nvPicPr>
        <p:blipFill rotWithShape="1">
          <a:blip r:embed="rId3">
            <a:alphaModFix/>
          </a:blip>
          <a:srcRect r="47443"/>
          <a:stretch/>
        </p:blipFill>
        <p:spPr>
          <a:xfrm>
            <a:off x="138492" y="369332"/>
            <a:ext cx="4371840" cy="3249531"/>
          </a:xfrm>
          <a:prstGeom prst="rect">
            <a:avLst/>
          </a:prstGeom>
          <a:noFill/>
          <a:ln>
            <a:noFill/>
          </a:ln>
        </p:spPr>
      </p:pic>
      <p:pic>
        <p:nvPicPr>
          <p:cNvPr id="112" name="Google Shape;112;p4"/>
          <p:cNvPicPr preferRelativeResize="0"/>
          <p:nvPr/>
        </p:nvPicPr>
        <p:blipFill rotWithShape="1">
          <a:blip r:embed="rId3">
            <a:alphaModFix/>
          </a:blip>
          <a:srcRect l="50766"/>
          <a:stretch/>
        </p:blipFill>
        <p:spPr>
          <a:xfrm>
            <a:off x="96851" y="3860356"/>
            <a:ext cx="4371840" cy="3468882"/>
          </a:xfrm>
          <a:prstGeom prst="rect">
            <a:avLst/>
          </a:prstGeom>
          <a:noFill/>
          <a:ln>
            <a:noFill/>
          </a:ln>
        </p:spPr>
      </p:pic>
      <p:sp>
        <p:nvSpPr>
          <p:cNvPr id="113" name="Google Shape;113;p4"/>
          <p:cNvSpPr/>
          <p:nvPr/>
        </p:nvSpPr>
        <p:spPr>
          <a:xfrm>
            <a:off x="-31327" y="7329238"/>
            <a:ext cx="5374034" cy="7078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4.</a:t>
            </a:r>
            <a:r>
              <a:rPr lang="en-GB" sz="1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Physical appearance of digested muffins at gastric time points DGM 1 (14 min), DGM 5 (70 min) and DGM 9 (126 min), with animated diagram.</a:t>
            </a:r>
            <a:endParaRPr sz="1000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</TotalTime>
  <Words>427</Words>
  <Application>Microsoft Macintosh PowerPoint</Application>
  <PresentationFormat>Custom</PresentationFormat>
  <Paragraphs>26</Paragraphs>
  <Slides>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lotte Mills</dc:creator>
  <cp:lastModifiedBy>Charlotte Mills</cp:lastModifiedBy>
  <cp:revision>10</cp:revision>
  <dcterms:created xsi:type="dcterms:W3CDTF">2020-07-07T22:06:57Z</dcterms:created>
  <dcterms:modified xsi:type="dcterms:W3CDTF">2020-11-19T21:52:14Z</dcterms:modified>
</cp:coreProperties>
</file>